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05" r:id="rId2"/>
  </p:sldIdLst>
  <p:sldSz cx="6858000" cy="9144000" type="screen4x3"/>
  <p:notesSz cx="6858000" cy="92964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00"/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781" autoAdjust="0"/>
    <p:restoredTop sz="94660"/>
  </p:normalViewPr>
  <p:slideViewPr>
    <p:cSldViewPr>
      <p:cViewPr>
        <p:scale>
          <a:sx n="80" d="100"/>
          <a:sy n="80" d="100"/>
        </p:scale>
        <p:origin x="-616" y="-4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6482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6482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pPr>
              <a:defRPr/>
            </a:pPr>
            <a:fld id="{5A8BE788-6749-47A3-9042-F40F24C43518}" type="datetimeFigureOut">
              <a:rPr lang="en-US"/>
              <a:pPr>
                <a:defRPr/>
              </a:pPr>
              <a:t>11/2/201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22488" y="696913"/>
            <a:ext cx="2613025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US" noProof="0" smtClean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15790"/>
            <a:ext cx="5486400" cy="418338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noProof="0" smtClean="0"/>
              <a:t>Click to edit Master text styles</a:t>
            </a:r>
          </a:p>
          <a:p>
            <a:pPr lvl="1"/>
            <a:r>
              <a:rPr lang="en-US" noProof="0" smtClean="0"/>
              <a:t>Second level</a:t>
            </a:r>
          </a:p>
          <a:p>
            <a:pPr lvl="2"/>
            <a:r>
              <a:rPr lang="en-US" noProof="0" smtClean="0"/>
              <a:t>Third level</a:t>
            </a:r>
          </a:p>
          <a:p>
            <a:pPr lvl="3"/>
            <a:r>
              <a:rPr lang="en-US" noProof="0" smtClean="0"/>
              <a:t>Fourth level</a:t>
            </a:r>
          </a:p>
          <a:p>
            <a:pPr lvl="4"/>
            <a:r>
              <a:rPr lang="en-US" noProof="0" smtClean="0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2971800" cy="46482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829967"/>
            <a:ext cx="2971800" cy="46482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pPr>
              <a:defRPr/>
            </a:pPr>
            <a:fld id="{7CD1F877-3280-4ACD-9240-E9E33373A2B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6596951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7CD1F877-3280-4ACD-9240-E9E33373A2BC}" type="slidenum">
              <a:rPr lang="en-US" smtClean="0"/>
              <a:pPr>
                <a:defRPr/>
              </a:pPr>
              <a:t>1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70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E2544FF-F1E3-4305-8D2C-4717EA669EA6}" type="datetimeFigureOut">
              <a:rPr lang="en-US"/>
              <a:pPr>
                <a:defRPr/>
              </a:pPr>
              <a:t>11/2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487FBA5-FCE8-463B-9734-E2435AB10F5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C9C4C8-F5EA-4502-83B4-7391888D2EA4}" type="datetimeFigureOut">
              <a:rPr lang="en-US"/>
              <a:pPr>
                <a:defRPr/>
              </a:pPr>
              <a:t>11/2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C585FF5-15CA-45AB-A4C9-AA114C48249D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7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7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0989FC0-261B-4A38-8066-CB67FF97A1C0}" type="datetimeFigureOut">
              <a:rPr lang="en-US"/>
              <a:pPr>
                <a:defRPr/>
              </a:pPr>
              <a:t>11/2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DD81995-07DF-49C2-B5A3-5353281E32F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532A341-200C-4E98-AE80-1ABFD60244F1}" type="datetimeFigureOut">
              <a:rPr lang="en-US"/>
              <a:pPr>
                <a:defRPr/>
              </a:pPr>
              <a:t>11/2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19C935-B237-4BFB-97B0-4CB0070C07E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1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581F6BD-386D-4A3F-A1AB-3B2E5B1A1152}" type="datetimeFigureOut">
              <a:rPr lang="en-US"/>
              <a:pPr>
                <a:defRPr/>
              </a:pPr>
              <a:t>11/2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EF88D7A-9E14-4005-81BC-651A87B32135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4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4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5BDCF7-3EC8-482A-AF77-03142BDE12C7}" type="datetimeFigureOut">
              <a:rPr lang="en-US"/>
              <a:pPr>
                <a:defRPr/>
              </a:pPr>
              <a:t>11/2/201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39194F9-7462-49B7-B4A8-C91151AB059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1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1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1C441BE-BF7C-4287-9FAB-10DA9CAF52DC}" type="datetimeFigureOut">
              <a:rPr lang="en-US"/>
              <a:pPr>
                <a:defRPr/>
              </a:pPr>
              <a:t>11/2/2012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13E06A0-4BA0-45CC-9192-8162A28C285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5D781F-2B80-4BFA-A8E2-0993EDA2193E}" type="datetimeFigureOut">
              <a:rPr lang="en-US"/>
              <a:pPr>
                <a:defRPr/>
              </a:pPr>
              <a:t>11/2/2012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35AB5CD-3051-4719-A293-E3EE9D9B159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E155A89-6BDD-40BB-9A85-B8B491215E3B}" type="datetimeFigureOut">
              <a:rPr lang="en-US"/>
              <a:pPr>
                <a:defRPr/>
              </a:pPr>
              <a:t>11/2/2012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E0CC0C9-5145-4576-8F16-29594118AEB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2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9" y="364070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2" y="1913470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F354D9B-6D30-470B-96E8-CAB0C57F2DF0}" type="datetimeFigureOut">
              <a:rPr lang="en-US"/>
              <a:pPr>
                <a:defRPr/>
              </a:pPr>
              <a:t>11/2/201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78BE73B-B04F-4CCB-8648-10FD994AE36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3344D3A-971F-4EAF-B902-077C1259D6FB}" type="datetimeFigureOut">
              <a:rPr lang="en-US"/>
              <a:pPr>
                <a:defRPr/>
              </a:pPr>
              <a:t>11/2/201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5496813-A644-4447-9420-4449C6759AB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22" name="Title Placeholder 1"/>
          <p:cNvSpPr>
            <a:spLocks noGrp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</a:p>
        </p:txBody>
      </p:sp>
      <p:sp>
        <p:nvSpPr>
          <p:cNvPr id="5123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663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F1400C1C-3319-44EA-8A96-453A4E8C0D1A}" type="datetimeFigureOut">
              <a:rPr lang="en-US"/>
              <a:pPr>
                <a:defRPr/>
              </a:pPr>
              <a:t>11/2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663"/>
            <a:ext cx="21717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663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13A10E13-F678-4BF5-9055-01AEA168A84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15438793"/>
              </p:ext>
            </p:extLst>
          </p:nvPr>
        </p:nvGraphicFramePr>
        <p:xfrm>
          <a:off x="342900" y="1828800"/>
          <a:ext cx="6172200" cy="2223438"/>
        </p:xfrm>
        <a:graphic>
          <a:graphicData uri="http://schemas.openxmlformats.org/drawingml/2006/table">
            <a:tbl>
              <a:tblPr firstRow="1" firstCol="1" bandRow="1">
                <a:tableStyleId>{073A0DAA-6AF3-43AB-8588-CEC1D06C72B9}</a:tableStyleId>
              </a:tblPr>
              <a:tblGrid>
                <a:gridCol w="748364"/>
                <a:gridCol w="2770873"/>
                <a:gridCol w="2652963"/>
              </a:tblGrid>
              <a:tr h="158817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Gene </a:t>
                      </a:r>
                      <a:endParaRPr lang="en-US" sz="1100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4971" marR="64971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Forward Sequence</a:t>
                      </a:r>
                      <a:endParaRPr lang="en-US" sz="11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4971" marR="64971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Reverse Sequence</a:t>
                      </a:r>
                      <a:endParaRPr lang="en-US" sz="11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4971" marR="64971" marT="0" marB="0"/>
                </a:tc>
              </a:tr>
              <a:tr h="158817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CG1575</a:t>
                      </a:r>
                      <a:endParaRPr lang="en-US" sz="11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4971" marR="64971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5’-AGATTCACTCCGTTTCTCAGC-3’</a:t>
                      </a:r>
                      <a:endParaRPr lang="en-US" sz="11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4971" marR="64971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5’-GACTATCTCAGGAGCAGAACG-3’</a:t>
                      </a:r>
                      <a:endParaRPr lang="en-US" sz="11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4971" marR="64971" marT="0" marB="0"/>
                </a:tc>
              </a:tr>
              <a:tr h="158817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CG17625</a:t>
                      </a:r>
                      <a:endParaRPr lang="en-US" sz="11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4971" marR="64971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5’-ACACCTGTTCCATATTCGCTAAC-3’</a:t>
                      </a:r>
                      <a:endParaRPr lang="en-US" sz="1100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4971" marR="64971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CCACACCTTTGACATTCCATTTG-3’</a:t>
                      </a:r>
                      <a:endParaRPr lang="en-US" sz="11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4971" marR="64971" marT="0" marB="0"/>
                </a:tc>
              </a:tr>
              <a:tr h="158817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Gclc</a:t>
                      </a:r>
                      <a:endParaRPr lang="en-US" sz="11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4971" marR="64971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5’-ATGACGAGGAGAATGAGCTG-3’</a:t>
                      </a:r>
                      <a:endParaRPr lang="en-US" sz="11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4971" marR="64971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5’-CCATGGACTGCAAATAGCTG-3’</a:t>
                      </a:r>
                      <a:endParaRPr lang="en-US" sz="11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4971" marR="64971" marT="0" marB="0"/>
                </a:tc>
              </a:tr>
              <a:tr h="158817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Gclc-RA</a:t>
                      </a:r>
                      <a:endParaRPr lang="en-US" sz="11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4971" marR="64971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5’-GGCAAATAACGTTACACAACCC-3’</a:t>
                      </a:r>
                      <a:endParaRPr lang="en-US" sz="11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4971" marR="64971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5’-CTCGCTCAGTAGACCCATTG-3’</a:t>
                      </a:r>
                      <a:endParaRPr lang="en-US" sz="11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4971" marR="64971" marT="0" marB="0"/>
                </a:tc>
              </a:tr>
              <a:tr h="158817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Gclc-RB</a:t>
                      </a:r>
                      <a:endParaRPr lang="en-US" sz="11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4971" marR="64971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5’-TCGGATCGGTTTCGTAAGAAAA-3’</a:t>
                      </a:r>
                      <a:endParaRPr lang="en-US" sz="11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4971" marR="64971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5’-CGATCCTTGAGTCTGTGGTAC-3’</a:t>
                      </a:r>
                      <a:endParaRPr lang="en-US" sz="11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4971" marR="64971" marT="0" marB="0"/>
                </a:tc>
              </a:tr>
              <a:tr h="158817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Gclm</a:t>
                      </a:r>
                      <a:endParaRPr lang="en-US" sz="11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4971" marR="64971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5’-ACGTCAGCAGGGCTACAAAC-3’</a:t>
                      </a:r>
                      <a:endParaRPr lang="en-US" sz="11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4971" marR="64971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5’-GGGCATATTGCTCCAGTGTT-3’</a:t>
                      </a:r>
                      <a:endParaRPr lang="en-US" sz="11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4971" marR="64971" marT="0" marB="0"/>
                </a:tc>
              </a:tr>
              <a:tr h="158817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GS</a:t>
                      </a:r>
                      <a:endParaRPr lang="en-US" sz="11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4971" marR="64971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5’-GACTCGTTGAATTTCGCC-3’</a:t>
                      </a:r>
                      <a:endParaRPr lang="en-US" sz="11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4971" marR="64971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5’-TCGTGATGAACTCCTCGT-3’</a:t>
                      </a:r>
                      <a:endParaRPr lang="en-US" sz="11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4971" marR="64971" marT="0" marB="0"/>
                </a:tc>
              </a:tr>
              <a:tr h="158817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gstD1</a:t>
                      </a:r>
                      <a:endParaRPr lang="en-US" sz="11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4971" marR="64971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5’-TCGAGGTGGCCAAATTCGAGATCA-3’</a:t>
                      </a:r>
                      <a:endParaRPr lang="en-US" sz="11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4971" marR="64971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5’-ACCACCTGTTCACATTGGCGTACT-3’</a:t>
                      </a:r>
                      <a:endParaRPr lang="en-US" sz="11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4971" marR="64971" marT="0" marB="0"/>
                </a:tc>
              </a:tr>
              <a:tr h="158817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cncC</a:t>
                      </a:r>
                      <a:endParaRPr lang="en-US" sz="11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4971" marR="64971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5’-TCGGAGATGACGAGGAGGAGAGT-3’</a:t>
                      </a:r>
                      <a:endParaRPr lang="en-US" sz="11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4971" marR="64971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5’-GCATTGATGATCGCCTCCTGGT-3’</a:t>
                      </a:r>
                      <a:endParaRPr lang="en-US" sz="11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4971" marR="64971" marT="0" marB="0"/>
                </a:tc>
              </a:tr>
              <a:tr h="158817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keap1</a:t>
                      </a:r>
                      <a:endParaRPr lang="en-US" sz="11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4971" marR="64971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5’-CGCCAGCTCCAAGGGGTGTGT-3’</a:t>
                      </a:r>
                      <a:endParaRPr lang="en-US" sz="11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4971" marR="64971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5’-CCAGAAAGGCACAGCAGGCATC-3’</a:t>
                      </a:r>
                      <a:endParaRPr lang="en-US" sz="11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4971" marR="64971" marT="0" marB="0"/>
                </a:tc>
              </a:tr>
              <a:tr h="158817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rp49</a:t>
                      </a:r>
                      <a:endParaRPr lang="en-US" sz="11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4971" marR="64971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5’-GCCCAGCATACAGGCCCAAG-3’</a:t>
                      </a:r>
                      <a:endParaRPr lang="en-US" sz="1100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4971" marR="64971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5’-AAGCGGCGACGCACTCTGTT-3’</a:t>
                      </a:r>
                      <a:endParaRPr lang="en-US" sz="11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4971" marR="64971" marT="0" marB="0"/>
                </a:tc>
              </a:tr>
              <a:tr h="158817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robl</a:t>
                      </a:r>
                      <a:endParaRPr lang="en-US" sz="11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4971" marR="64971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5’-AATCCAGAGCCACAAAGGTG-3’</a:t>
                      </a:r>
                      <a:endParaRPr lang="en-US" sz="11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4971" marR="64971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5’-AGTGTTGTCCAGCGTGGATT-3’</a:t>
                      </a:r>
                      <a:endParaRPr lang="en-US" sz="11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4971" marR="64971" marT="0" marB="0"/>
                </a:tc>
              </a:tr>
              <a:tr h="158817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tim</a:t>
                      </a:r>
                      <a:endParaRPr lang="en-US" sz="11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4971" marR="64971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5’-GTGCTTCTGCTGAGGCGTTTCAAT-3’</a:t>
                      </a:r>
                      <a:endParaRPr lang="en-US" sz="1100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4971" marR="64971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5’-GGCGAATGGTTTGACATCCACCAA-3’</a:t>
                      </a:r>
                      <a:endParaRPr lang="en-US" sz="1100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4971" marR="64971" marT="0" marB="0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1569798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970</TotalTime>
  <Words>121</Words>
  <Application>Microsoft Office PowerPoint</Application>
  <PresentationFormat>On-screen Show (4:3)</PresentationFormat>
  <Paragraphs>43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Oregon State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Laura M Beaver</dc:creator>
  <cp:lastModifiedBy>Giebultowicz, Jaga</cp:lastModifiedBy>
  <cp:revision>194</cp:revision>
  <dcterms:created xsi:type="dcterms:W3CDTF">2012-08-09T15:56:20Z</dcterms:created>
  <dcterms:modified xsi:type="dcterms:W3CDTF">2012-11-02T21:32:29Z</dcterms:modified>
</cp:coreProperties>
</file>